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85A3355-B255-4AE2-AFED-9702A6447616}" v="4" dt="2026-03-31T00:54:55.8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88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辰巳　めぐみ" userId="S::megumi_tatsumi@ncnp.go.jp::88b1893c-db63-4bb5-9dca-a6ce3447aab8" providerId="AD" clId="Web-{C85A3355-B255-4AE2-AFED-9702A6447616}"/>
    <pc:docChg chg="modSld">
      <pc:chgData name="辰巳　めぐみ" userId="S::megumi_tatsumi@ncnp.go.jp::88b1893c-db63-4bb5-9dca-a6ce3447aab8" providerId="AD" clId="Web-{C85A3355-B255-4AE2-AFED-9702A6447616}" dt="2026-03-31T00:54:55.861" v="1" actId="20577"/>
      <pc:docMkLst>
        <pc:docMk/>
      </pc:docMkLst>
      <pc:sldChg chg="modSp">
        <pc:chgData name="辰巳　めぐみ" userId="S::megumi_tatsumi@ncnp.go.jp::88b1893c-db63-4bb5-9dca-a6ce3447aab8" providerId="AD" clId="Web-{C85A3355-B255-4AE2-AFED-9702A6447616}" dt="2026-03-31T00:54:55.861" v="1" actId="20577"/>
        <pc:sldMkLst>
          <pc:docMk/>
          <pc:sldMk cId="3285713202" sldId="256"/>
        </pc:sldMkLst>
        <pc:spChg chg="mod">
          <ac:chgData name="辰巳　めぐみ" userId="S::megumi_tatsumi@ncnp.go.jp::88b1893c-db63-4bb5-9dca-a6ce3447aab8" providerId="AD" clId="Web-{C85A3355-B255-4AE2-AFED-9702A6447616}" dt="2026-03-31T00:54:55.861" v="1" actId="20577"/>
          <ac:spMkLst>
            <pc:docMk/>
            <pc:sldMk cId="3285713202" sldId="256"/>
            <ac:spMk id="5" creationId="{131A1956-03FD-E9AD-3AD1-02E5585409F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83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222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442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824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65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631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926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250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1329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985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620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979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31A1956-03FD-E9AD-3AD1-02E5585409FB}"/>
              </a:ext>
            </a:extLst>
          </p:cNvPr>
          <p:cNvSpPr txBox="1"/>
          <p:nvPr/>
        </p:nvSpPr>
        <p:spPr>
          <a:xfrm>
            <a:off x="1144945" y="4606048"/>
            <a:ext cx="6854109" cy="52322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>
              <a:spcAft>
                <a:spcPts val="1000"/>
              </a:spcAft>
            </a:pPr>
            <a:r>
              <a:rPr lang="en-US" altLang="ja-JP" sz="1400" b="1">
                <a:effectLst/>
                <a:latin typeface="Times"/>
                <a:ea typeface="游明朝"/>
                <a:cs typeface="Times New Roman"/>
              </a:rPr>
              <a:t>Figure </a:t>
            </a:r>
            <a:r>
              <a:rPr lang="en-US" altLang="ja-JP" sz="1400" b="1">
                <a:latin typeface="Times"/>
                <a:ea typeface="游明朝"/>
                <a:cs typeface="Times New Roman"/>
              </a:rPr>
              <a:t>S11</a:t>
            </a:r>
            <a:r>
              <a:rPr lang="en-US" altLang="ja-JP" sz="1400" b="1">
                <a:effectLst/>
                <a:latin typeface="Times"/>
                <a:ea typeface="游明朝"/>
                <a:cs typeface="Times New Roman"/>
              </a:rPr>
              <a:t>.</a:t>
            </a:r>
            <a:r>
              <a:rPr lang="en-US" altLang="ja-JP" sz="1400">
                <a:effectLst/>
                <a:latin typeface="Times"/>
                <a:ea typeface="游明朝"/>
                <a:cs typeface="Times New Roman"/>
              </a:rPr>
              <a:t> </a:t>
            </a:r>
            <a:r>
              <a:rPr lang="en-US" altLang="ja-JP" sz="1400" b="1" dirty="0">
                <a:effectLst/>
                <a:latin typeface="Times"/>
                <a:ea typeface="游明朝"/>
                <a:cs typeface="Times New Roman"/>
              </a:rPr>
              <a:t>Impact of centrifugation conditions on the CSF proteome analyzed by volcano plots.</a:t>
            </a:r>
            <a:endParaRPr lang="ja-JP" altLang="ja-JP" sz="1400" dirty="0">
              <a:effectLst/>
              <a:latin typeface="Times"/>
              <a:ea typeface="游明朝"/>
              <a:cs typeface="Times New Roman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CEC906BA-087C-E285-A739-ACE01B8098FC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144945" y="1414267"/>
            <a:ext cx="2628000" cy="2628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5EC57144-EB88-D248-EA04-66A27AA1F32B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991410" y="1414267"/>
            <a:ext cx="2628000" cy="2628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5F00EBC-88C5-8652-744C-4CC833453932}"/>
              </a:ext>
            </a:extLst>
          </p:cNvPr>
          <p:cNvSpPr txBox="1"/>
          <p:nvPr/>
        </p:nvSpPr>
        <p:spPr>
          <a:xfrm>
            <a:off x="1144945" y="123909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53ADEAD-6F19-9B30-CC41-89D5DC5A1D2F}"/>
              </a:ext>
            </a:extLst>
          </p:cNvPr>
          <p:cNvSpPr txBox="1"/>
          <p:nvPr/>
        </p:nvSpPr>
        <p:spPr>
          <a:xfrm>
            <a:off x="5155963" y="123909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E92C0CE-F2B4-510C-2FEE-99244F8F650F}"/>
              </a:ext>
            </a:extLst>
          </p:cNvPr>
          <p:cNvSpPr txBox="1"/>
          <p:nvPr/>
        </p:nvSpPr>
        <p:spPr>
          <a:xfrm>
            <a:off x="1859166" y="3969758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722913B-C277-29A4-2245-0B68E8C8F127}"/>
              </a:ext>
            </a:extLst>
          </p:cNvPr>
          <p:cNvSpPr txBox="1"/>
          <p:nvPr/>
        </p:nvSpPr>
        <p:spPr>
          <a:xfrm rot="16200000">
            <a:off x="433992" y="2589767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AC56BE6-6466-6CC4-CCF3-581785D429E3}"/>
              </a:ext>
            </a:extLst>
          </p:cNvPr>
          <p:cNvSpPr txBox="1"/>
          <p:nvPr/>
        </p:nvSpPr>
        <p:spPr>
          <a:xfrm>
            <a:off x="5747994" y="3969758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4F165F0-0F31-CB95-5F0D-EA8E1D89FEDF}"/>
              </a:ext>
            </a:extLst>
          </p:cNvPr>
          <p:cNvSpPr txBox="1"/>
          <p:nvPr/>
        </p:nvSpPr>
        <p:spPr>
          <a:xfrm rot="16200000">
            <a:off x="4322820" y="2589767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571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9e658bc-5f5e-48b2-a593-8f2a4dff4e86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4E485A41FBE0840AEF03DC6126CF7E9" ma:contentTypeVersion="10" ma:contentTypeDescription="新しいドキュメントを作成します。" ma:contentTypeScope="" ma:versionID="b7fc72b48302197a3c00e12c5a71d0f2">
  <xsd:schema xmlns:xsd="http://www.w3.org/2001/XMLSchema" xmlns:xs="http://www.w3.org/2001/XMLSchema" xmlns:p="http://schemas.microsoft.com/office/2006/metadata/properties" xmlns:ns2="09e658bc-5f5e-48b2-a593-8f2a4dff4e86" targetNamespace="http://schemas.microsoft.com/office/2006/metadata/properties" ma:root="true" ma:fieldsID="3811df9a92dabbc9fbde200746e96434" ns2:_="">
    <xsd:import namespace="09e658bc-5f5e-48b2-a593-8f2a4dff4e8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e658bc-5f5e-48b2-a593-8f2a4dff4e8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画像タグ" ma:readOnly="false" ma:fieldId="{5cf76f15-5ced-4ddc-b409-7134ff3c332f}" ma:taxonomyMulti="true" ma:sspId="559d5a2e-65d4-4456-94da-aa20a3af47a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2B9905A-FA1D-4BF2-B6A6-31D56198867E}">
  <ds:schemaRefs>
    <ds:schemaRef ds:uri="http://schemas.openxmlformats.org/package/2006/metadata/core-properties"/>
    <ds:schemaRef ds:uri="http://www.w3.org/XML/1998/namespace"/>
    <ds:schemaRef ds:uri="http://purl.org/dc/elements/1.1/"/>
    <ds:schemaRef ds:uri="http://purl.org/dc/terms/"/>
    <ds:schemaRef ds:uri="09e658bc-5f5e-48b2-a593-8f2a4dff4e86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DD3B6CB2-80C3-4ECF-B749-13137F71D85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6671157-B7D0-4BF9-BE79-E9EC00917C8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9e658bc-5f5e-48b2-a593-8f2a4dff4e8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</TotalTime>
  <Words>30</Words>
  <Application>Microsoft Office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辰巳　めぐみ</dc:creator>
  <cp:lastModifiedBy>辰巳　めぐみ</cp:lastModifiedBy>
  <cp:revision>12</cp:revision>
  <dcterms:created xsi:type="dcterms:W3CDTF">2025-03-28T03:13:18Z</dcterms:created>
  <dcterms:modified xsi:type="dcterms:W3CDTF">2026-03-31T08:01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4E485A41FBE0840AEF03DC6126CF7E9</vt:lpwstr>
  </property>
  <property fmtid="{D5CDD505-2E9C-101B-9397-08002B2CF9AE}" pid="3" name="MediaServiceImageTags">
    <vt:lpwstr/>
  </property>
</Properties>
</file>